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A3237FA-2EA5-45FA-8DAB-F6982A7ECC43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8226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6840" y="3962160"/>
            <a:ext cx="8226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9445F63-F426-442F-AC4D-3E4031DA39CF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68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24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7AAA8DE-AC3F-4BF6-A1BA-914B2A15A75E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8200" y="159984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19560" y="159984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6840" y="396216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8200" y="396216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19560" y="396216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BE33711-8EB7-4E5F-AB18-9D29DB98224E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6840" y="1599840"/>
            <a:ext cx="8226360" cy="4522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77786E2-A3F7-4E44-8B69-FAE1E866F42A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8226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8C8747A-45B7-4316-890A-3687EFCC33BD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6644330-49DB-421F-9E2E-6E79AC92DF3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C308A27-325A-4694-8CA6-63706FBAFE28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6840" y="274680"/>
            <a:ext cx="8226360" cy="528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EEB1CA9-896B-4E93-AEA8-A9D4A58EC23C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68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375A1CB-8008-4ABF-A847-2BD3D95A2E6D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24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42C74D7-E2EE-44E6-8B92-CCCDFD546151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6840" y="3962160"/>
            <a:ext cx="8226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3944E54-C4F8-4A67-B852-B9AE608DB13A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6840" y="1599840"/>
            <a:ext cx="8226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5720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245280"/>
            <a:ext cx="28958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6553080" y="6245280"/>
            <a:ext cx="2130480" cy="47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pt-BR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4C6C0599-6B9A-4855-AA76-FB9E8200C9BA}" type="slidenum">
              <a:rPr b="0" lang="pt-BR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276720" y="2286000"/>
            <a:ext cx="1860480" cy="15238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5257800" y="2286000"/>
            <a:ext cx="1792440" cy="15447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882960" y="422280"/>
            <a:ext cx="245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pLKO                            IBC-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649680" y="152280"/>
            <a:ext cx="2800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MDA-MB-361 tumor xenograf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581280" y="422280"/>
            <a:ext cx="2971800" cy="144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81120" y="434340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HER-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523960" y="1574640"/>
            <a:ext cx="67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523960" y="274320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</a:rPr>
              <a:t>HER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2475720" y="76320"/>
            <a:ext cx="5372280" cy="6629400"/>
          </a:xfrm>
          <a:prstGeom prst="rect">
            <a:avLst/>
          </a:pr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3"/>
          <a:stretch/>
        </p:blipFill>
        <p:spPr>
          <a:xfrm>
            <a:off x="3276720" y="717480"/>
            <a:ext cx="1860480" cy="14940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4"/>
          <a:stretch/>
        </p:blipFill>
        <p:spPr>
          <a:xfrm>
            <a:off x="5257800" y="716040"/>
            <a:ext cx="1771560" cy="14936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5"/>
          <a:stretch/>
        </p:blipFill>
        <p:spPr>
          <a:xfrm>
            <a:off x="3276720" y="3886200"/>
            <a:ext cx="1860480" cy="161460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6"/>
          <a:stretch/>
        </p:blipFill>
        <p:spPr>
          <a:xfrm>
            <a:off x="5257800" y="3886200"/>
            <a:ext cx="1792440" cy="163656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2992320" y="5767560"/>
            <a:ext cx="4572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Arial"/>
              </a:rPr>
              <a:t>Additional file 6: Figure S2. 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Representative</a:t>
            </a:r>
            <a:r>
              <a:rPr b="1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immunohistochemical (IHC) analysis of EGFR, HER-2/ErbB-2 and HER-4/ErbB4 in xenografts derived from control and DCD shRNA expressing MDA-MB-361 cells. Magnification 400x</a:t>
            </a:r>
            <a:r>
              <a:rPr b="1" lang="pt-BR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0T23:48:47Z</dcterms:created>
  <dc:creator>jose</dc:creator>
  <dc:description/>
  <dc:language>en-US</dc:language>
  <cp:lastModifiedBy>Windows XP PRO</cp:lastModifiedBy>
  <dcterms:modified xsi:type="dcterms:W3CDTF">2014-04-24T22:13:19Z</dcterms:modified>
  <cp:revision>29</cp:revision>
  <dc:subject/>
  <dc:title>Slide 1</dc:title>
</cp:coreProperties>
</file>